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2A6894-A8B7-4475-96A7-7613E5E00C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0695B-0F6C-45D4-A6D0-E610317CF2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92ED39-4FE2-4FB1-B2DF-E6D8E5F04C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BE0D24-5E76-470D-A120-EBDAF9301B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4C443A-0A49-4F62-BC0F-9F1F4D9EDD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CECF5C-025B-4479-84C2-E6021D8BD2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184FFB-569C-48BF-9745-73F9E0BF39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5D60B-99CC-4CD1-8167-2E2F69855C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CF1C19-A6C6-493E-9C2A-632690045C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C16FB-0E6E-4C3A-BDB5-B375AFB5FC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44FD79-98E3-445B-AB1D-1089EC5640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B4737D-3782-4D1D-A80B-811E07FFBF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4C7F8A-2058-411D-AC78-5FC655F6B472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28600" y="1295280"/>
            <a:ext cx="8686800" cy="31244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28600" y="4648320"/>
            <a:ext cx="876312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upplementary </a:t>
            </a: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ure 1.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Comparative immunolocalization of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ColIV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in normal group, dysplastic oral mucosa group and OTSCC (T and S indicate the tumour and stroma respectively) by immunofluorescence. (A) The expression of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ColIV in the BM of normal group showing linear and continuous marking (red arrow). (B)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The expression of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ColIV in the BM of normal group showing interrupted (red arrow). (C) In the OTSCC, the expression of ColIV are showed fragmented or collapsed (red arrow). Original magnification,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200×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04920" y="304920"/>
            <a:ext cx="8458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upplementary </a:t>
            </a: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ure 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Immunofluorescence staining for ColIV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in normal group, dysplastic oral mucosa group and OTSCC grou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457200" y="4648320"/>
            <a:ext cx="830592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upplementary</a:t>
            </a: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 Figure 2.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Expression of PCNA and MMP-9 proteins detected by double immunofluorescence staining in the stromal of OTSCC (S indicate the stroma). (A) The expression of PCNA in the stromal cells (red). (B) The expression of MMP-9 in the stromal cells (green). (C) Double-labeled cells of PCNA/MMP-9 in the OTSCC.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Original magnification,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200×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380880" y="1447920"/>
            <a:ext cx="8458200" cy="274320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304920" y="457200"/>
            <a:ext cx="8458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upplementary </a:t>
            </a: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ure 2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Double immunofluorescence staining for PCNA and MMP-9 in the stromal of OTSC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0T05:50:57Z</dcterms:created>
  <dc:creator>范静</dc:creator>
  <dc:description/>
  <dc:language>en-US</dc:language>
  <cp:lastModifiedBy>JUJUMAO</cp:lastModifiedBy>
  <dcterms:modified xsi:type="dcterms:W3CDTF">2012-10-20T07:22:54Z</dcterms:modified>
  <cp:revision>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